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318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543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4663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2017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2693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9276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911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4828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9497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617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110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E75DCA-AEE7-4D51-9DF7-27DE684D2604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9B8D8-1828-4737-8EF6-2CF0A59D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0698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86" t="14855" r="53779" b="69203"/>
          <a:stretch/>
        </p:blipFill>
        <p:spPr>
          <a:xfrm>
            <a:off x="3254187" y="3361761"/>
            <a:ext cx="860612" cy="5916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00" t="23736" r="53929" b="62019"/>
          <a:stretch/>
        </p:blipFill>
        <p:spPr>
          <a:xfrm>
            <a:off x="4155140" y="3361761"/>
            <a:ext cx="820271" cy="5916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60" t="54840" r="60029" b="35886"/>
          <a:stretch/>
        </p:blipFill>
        <p:spPr>
          <a:xfrm>
            <a:off x="3254187" y="2864226"/>
            <a:ext cx="854763" cy="457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30" t="47788" r="46804" b="37168"/>
          <a:stretch/>
        </p:blipFill>
        <p:spPr>
          <a:xfrm>
            <a:off x="4155139" y="2864226"/>
            <a:ext cx="820271" cy="4572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矩形 7"/>
          <p:cNvSpPr/>
          <p:nvPr/>
        </p:nvSpPr>
        <p:spPr>
          <a:xfrm>
            <a:off x="2886293" y="1870219"/>
            <a:ext cx="267893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/>
          </a:p>
        </p:txBody>
      </p:sp>
      <p:sp>
        <p:nvSpPr>
          <p:cNvPr id="9" name="文本框 8"/>
          <p:cNvSpPr txBox="1"/>
          <p:nvPr/>
        </p:nvSpPr>
        <p:spPr>
          <a:xfrm>
            <a:off x="3341594" y="2245660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740413" y="2545843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376905" y="2563773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731010" y="2568256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031874" y="2223249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282337" y="256825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663336" y="2572739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6" name="直接连接符 15"/>
          <p:cNvCxnSpPr/>
          <p:nvPr/>
        </p:nvCxnSpPr>
        <p:spPr>
          <a:xfrm>
            <a:off x="3339190" y="2597662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4231175" y="2588698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4963387" y="3477156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975410" y="2923549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724745" y="297471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3137037" y="311710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2715781" y="355742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3128073" y="369980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97619" y="320815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g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235157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32" t="32016" r="38448" b="60643"/>
          <a:stretch/>
        </p:blipFill>
        <p:spPr>
          <a:xfrm>
            <a:off x="3388661" y="3939986"/>
            <a:ext cx="1909480" cy="4840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43" t="44596" r="41815" b="50546"/>
          <a:stretch/>
        </p:blipFill>
        <p:spPr>
          <a:xfrm>
            <a:off x="3388661" y="3375216"/>
            <a:ext cx="1909480" cy="5109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5298141" y="4012268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342965" y="3492318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859216" y="355293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3271508" y="369531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2877146" y="410874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3289438" y="425112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矩形 12"/>
          <p:cNvSpPr/>
          <p:nvPr/>
        </p:nvSpPr>
        <p:spPr>
          <a:xfrm>
            <a:off x="2899557" y="2475604"/>
            <a:ext cx="267893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/>
          </a:p>
        </p:txBody>
      </p:sp>
      <p:sp>
        <p:nvSpPr>
          <p:cNvPr id="14" name="文本框 13"/>
          <p:cNvSpPr txBox="1"/>
          <p:nvPr/>
        </p:nvSpPr>
        <p:spPr>
          <a:xfrm>
            <a:off x="3516406" y="2783538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915225" y="3083721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551717" y="3101651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905822" y="3106134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300815" y="2761127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443702" y="3106134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932277" y="3110617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3514002" y="3135540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4500116" y="3126576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239177" y="711321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g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6715831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39177" y="711321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g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06" t="38489" r="31528" b="44443"/>
          <a:stretch/>
        </p:blipFill>
        <p:spPr>
          <a:xfrm>
            <a:off x="2899675" y="3230960"/>
            <a:ext cx="2138083" cy="6992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99675" y="2732863"/>
            <a:ext cx="2143162" cy="4443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矩形 4"/>
          <p:cNvSpPr/>
          <p:nvPr/>
        </p:nvSpPr>
        <p:spPr>
          <a:xfrm>
            <a:off x="2599015" y="1725972"/>
            <a:ext cx="267893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/>
          </a:p>
        </p:txBody>
      </p:sp>
      <p:sp>
        <p:nvSpPr>
          <p:cNvPr id="6" name="文本框 5"/>
          <p:cNvSpPr txBox="1"/>
          <p:nvPr/>
        </p:nvSpPr>
        <p:spPr>
          <a:xfrm>
            <a:off x="3282915" y="2063313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681734" y="2374702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318226" y="2392632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672331" y="2397115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973195" y="2063313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223658" y="2397115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604657" y="2401598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3280511" y="2426521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4172496" y="2417557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5012284" y="3386697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024307" y="2765855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357159" y="352442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2733667" y="3681575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2361642" y="324652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2724703" y="3403671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2393019" y="282070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2756080" y="2977850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986729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7945" y="1809975"/>
            <a:ext cx="3982883" cy="2950284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77385" y="958339"/>
            <a:ext cx="53686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g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258237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69</Words>
  <Application>Microsoft Office PowerPoint</Application>
  <PresentationFormat>全屏显示(4:3)</PresentationFormat>
  <Paragraphs>41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9</cp:revision>
  <dcterms:created xsi:type="dcterms:W3CDTF">2020-08-31T05:25:59Z</dcterms:created>
  <dcterms:modified xsi:type="dcterms:W3CDTF">2020-10-09T02:40:50Z</dcterms:modified>
</cp:coreProperties>
</file>